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 showGuides="1">
      <p:cViewPr>
        <p:scale>
          <a:sx n="150" d="100"/>
          <a:sy n="150" d="100"/>
        </p:scale>
        <p:origin x="-72" y="6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JY\Desktop\mTOR\western%20blot%20analysis_18100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50"/>
            </a:pPr>
            <a:r>
              <a:rPr lang="en-US" altLang="ko-KR" sz="1050"/>
              <a:t>p-ERK(thr202/204)/ERK</a:t>
            </a:r>
            <a:endParaRPr lang="ko-KR" altLang="en-US" sz="105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1"/>
          <c:order val="0"/>
          <c:tx>
            <c:strRef>
              <c:f>'통계처리-7 180928'!$N$33</c:f>
              <c:strCache>
                <c:ptCount val="1"/>
                <c:pt idx="0">
                  <c:v>RPE/Choroid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통계처리-7 180928'!$N$19:$N$23</c:f>
                <c:numCache>
                  <c:formatCode>General</c:formatCode>
                  <c:ptCount val="5"/>
                  <c:pt idx="0">
                    <c:v>9.9359773995749787</c:v>
                  </c:pt>
                  <c:pt idx="1">
                    <c:v>11.522565609543129</c:v>
                  </c:pt>
                  <c:pt idx="2">
                    <c:v>8.3386135023594381</c:v>
                  </c:pt>
                  <c:pt idx="3">
                    <c:v>11.962022664509703</c:v>
                  </c:pt>
                  <c:pt idx="4">
                    <c:v>14.587829698999352</c:v>
                  </c:pt>
                </c:numCache>
              </c:numRef>
            </c:plus>
            <c:minus>
              <c:numRef>
                <c:f>'통계처리-7 180928'!$N$19:$N$23</c:f>
                <c:numCache>
                  <c:formatCode>General</c:formatCode>
                  <c:ptCount val="5"/>
                  <c:pt idx="0">
                    <c:v>9.9359773995749787</c:v>
                  </c:pt>
                  <c:pt idx="1">
                    <c:v>11.522565609543129</c:v>
                  </c:pt>
                  <c:pt idx="2">
                    <c:v>8.3386135023594381</c:v>
                  </c:pt>
                  <c:pt idx="3">
                    <c:v>11.962022664509703</c:v>
                  </c:pt>
                  <c:pt idx="4">
                    <c:v>14.587829698999352</c:v>
                  </c:pt>
                </c:numCache>
              </c:numRef>
            </c:minus>
          </c:errBars>
          <c:cat>
            <c:strRef>
              <c:f>'통계처리-7 180928'!$L$34:$L$38</c:f>
              <c:strCache>
                <c:ptCount val="5"/>
                <c:pt idx="0">
                  <c:v>Normal</c:v>
                </c:pt>
                <c:pt idx="1">
                  <c:v>CNV3d</c:v>
                </c:pt>
                <c:pt idx="2">
                  <c:v>CNV5d</c:v>
                </c:pt>
                <c:pt idx="3">
                  <c:v>CNV7d</c:v>
                </c:pt>
                <c:pt idx="4">
                  <c:v>CNV12d</c:v>
                </c:pt>
              </c:strCache>
            </c:strRef>
          </c:cat>
          <c:val>
            <c:numRef>
              <c:f>'통계처리-7 180928'!$N$12:$N$16</c:f>
              <c:numCache>
                <c:formatCode>0.000_ </c:formatCode>
                <c:ptCount val="5"/>
                <c:pt idx="0">
                  <c:v>100</c:v>
                </c:pt>
                <c:pt idx="1">
                  <c:v>590.42437490410032</c:v>
                </c:pt>
                <c:pt idx="2">
                  <c:v>212.11099764808753</c:v>
                </c:pt>
                <c:pt idx="3">
                  <c:v>178.48760707471402</c:v>
                </c:pt>
                <c:pt idx="4">
                  <c:v>290.066544453116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936-434E-8818-18286AE3B6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5"/>
        <c:axId val="64678912"/>
        <c:axId val="71258880"/>
      </c:barChart>
      <c:catAx>
        <c:axId val="64678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71258880"/>
        <c:crosses val="autoZero"/>
        <c:auto val="1"/>
        <c:lblAlgn val="ctr"/>
        <c:lblOffset val="100"/>
        <c:noMultiLvlLbl val="0"/>
      </c:catAx>
      <c:valAx>
        <c:axId val="71258880"/>
        <c:scaling>
          <c:orientation val="minMax"/>
        </c:scaling>
        <c:delete val="0"/>
        <c:axPos val="l"/>
        <c:numFmt formatCode="0_ " sourceLinked="0"/>
        <c:majorTickMark val="none"/>
        <c:minorTickMark val="none"/>
        <c:tickLblPos val="nextTo"/>
        <c:spPr>
          <a:ln w="9525">
            <a:noFill/>
          </a:ln>
        </c:spPr>
        <c:txPr>
          <a:bodyPr/>
          <a:lstStyle/>
          <a:p>
            <a:pPr>
              <a:defRPr sz="800"/>
            </a:pPr>
            <a:endParaRPr lang="en-US"/>
          </a:p>
        </c:txPr>
        <c:crossAx val="64678912"/>
        <c:crosses val="autoZero"/>
        <c:crossBetween val="between"/>
      </c:valAx>
    </c:plotArea>
    <c:legend>
      <c:legendPos val="b"/>
      <c:layout/>
      <c:overlay val="0"/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E0EB0E-87BF-40D9-92C8-B6F09C579D46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C24F3-D4E5-4FC0-B4C1-C149A97679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2435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E0EB0E-87BF-40D9-92C8-B6F09C579D46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C24F3-D4E5-4FC0-B4C1-C149A97679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4941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E0EB0E-87BF-40D9-92C8-B6F09C579D46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C24F3-D4E5-4FC0-B4C1-C149A97679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8850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E0EB0E-87BF-40D9-92C8-B6F09C579D46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C24F3-D4E5-4FC0-B4C1-C149A97679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8833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E0EB0E-87BF-40D9-92C8-B6F09C579D46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C24F3-D4E5-4FC0-B4C1-C149A97679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08627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E0EB0E-87BF-40D9-92C8-B6F09C579D46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C24F3-D4E5-4FC0-B4C1-C149A97679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6178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E0EB0E-87BF-40D9-92C8-B6F09C579D46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C24F3-D4E5-4FC0-B4C1-C149A97679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4978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E0EB0E-87BF-40D9-92C8-B6F09C579D46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C24F3-D4E5-4FC0-B4C1-C149A97679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0069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E0EB0E-87BF-40D9-92C8-B6F09C579D46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C24F3-D4E5-4FC0-B4C1-C149A97679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17198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E0EB0E-87BF-40D9-92C8-B6F09C579D46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C24F3-D4E5-4FC0-B4C1-C149A97679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8664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E0EB0E-87BF-40D9-92C8-B6F09C579D46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4C24F3-D4E5-4FC0-B4C1-C149A97679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144694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E0EB0E-87BF-40D9-92C8-B6F09C579D46}" type="datetimeFigureOut">
              <a:rPr lang="ko-KR" altLang="en-US" smtClean="0"/>
              <a:t>2019-06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4C24F3-D4E5-4FC0-B4C1-C149A976798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6145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565242" y="1676276"/>
            <a:ext cx="953171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800">
                <a:latin typeface="Times New Roman" panose="02020603050405020304" pitchFamily="18" charset="0"/>
                <a:cs typeface="Times New Roman" panose="02020603050405020304" pitchFamily="18" charset="0"/>
              </a:rPr>
              <a:t>pERK</a:t>
            </a:r>
          </a:p>
          <a:p>
            <a:pPr algn="ctr"/>
            <a:r>
              <a:rPr lang="en-US" altLang="ko-KR" sz="800">
                <a:latin typeface="Times New Roman" panose="02020603050405020304" pitchFamily="18" charset="0"/>
                <a:cs typeface="Times New Roman" panose="02020603050405020304" pitchFamily="18" charset="0"/>
              </a:rPr>
              <a:t>(Thr202/Tyr204)</a:t>
            </a:r>
            <a:endParaRPr lang="ko-KR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651339" y="2067697"/>
            <a:ext cx="786113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800">
                <a:latin typeface="Times New Roman" panose="02020603050405020304" pitchFamily="18" charset="0"/>
                <a:cs typeface="Times New Roman" panose="02020603050405020304" pitchFamily="18" charset="0"/>
              </a:rPr>
              <a:t>ERK</a:t>
            </a:r>
          </a:p>
        </p:txBody>
      </p:sp>
      <p:pic>
        <p:nvPicPr>
          <p:cNvPr id="6" name="그림 5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900" t="11688" r="25446" b="82395"/>
          <a:stretch/>
        </p:blipFill>
        <p:spPr>
          <a:xfrm>
            <a:off x="1511469" y="2060079"/>
            <a:ext cx="1296000" cy="189000"/>
          </a:xfrm>
          <a:prstGeom prst="rect">
            <a:avLst/>
          </a:prstGeom>
        </p:spPr>
      </p:pic>
      <p:pic>
        <p:nvPicPr>
          <p:cNvPr id="7" name="Picture 3"/>
          <p:cNvPicPr preferRelativeResize="0">
            <a:picLocks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43" t="48175" r="31629" b="40379"/>
          <a:stretch/>
        </p:blipFill>
        <p:spPr bwMode="auto">
          <a:xfrm>
            <a:off x="1511469" y="2369111"/>
            <a:ext cx="1296000" cy="190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809389" y="2336013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altLang="ko-KR" sz="80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ko-KR" sz="80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ko-KR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451205" y="1064568"/>
            <a:ext cx="146034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>
                <a:latin typeface="Times New Roman" panose="02020603050405020304" pitchFamily="18" charset="0"/>
                <a:cs typeface="Times New Roman" panose="02020603050405020304" pitchFamily="18" charset="0"/>
              </a:rPr>
              <a:t>RPE/Choroid</a:t>
            </a:r>
            <a:endParaRPr lang="ko-KR" altLang="en-US" sz="9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angle 2"/>
          <p:cNvSpPr/>
          <p:nvPr/>
        </p:nvSpPr>
        <p:spPr>
          <a:xfrm>
            <a:off x="115889" y="3183310"/>
            <a:ext cx="662548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/>
              <a:t>Additional file </a:t>
            </a:r>
            <a:r>
              <a:rPr lang="en-US" sz="1000" b="1" dirty="0" smtClean="0"/>
              <a:t>1: Figure S1. </a:t>
            </a:r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total ERK and p-ERK detected by Western blot. </a:t>
            </a:r>
          </a:p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– Expression of indicated proteins</a:t>
            </a:r>
          </a:p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– The expression of p-ERK (Thr202/Tyr204) relative to total ERK levels in RPE/Choroid. Data are presented as the mean ± S.E.M.</a:t>
            </a:r>
            <a:endParaRPr lang="en-US" altLang="ko-KR" sz="1000" b="1" dirty="0">
              <a:latin typeface="Times New Roman" panose="02020603050405020304" pitchFamily="18" charset="0"/>
              <a:ea typeface="맑은 고딕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85428" y="1064572"/>
            <a:ext cx="3179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af-ZA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flipH="1">
            <a:off x="4331417" y="1494699"/>
            <a:ext cx="19984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13" name="TextBox 12"/>
          <p:cNvSpPr txBox="1"/>
          <p:nvPr/>
        </p:nvSpPr>
        <p:spPr>
          <a:xfrm flipH="1">
            <a:off x="4899846" y="1961963"/>
            <a:ext cx="1998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  <a:p>
            <a:pPr algn="ctr"/>
            <a:r>
              <a:rPr lang="en-US" altLang="ko-KR" sz="50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</a:p>
        </p:txBody>
      </p:sp>
      <p:sp>
        <p:nvSpPr>
          <p:cNvPr id="14" name="TextBox 13"/>
          <p:cNvSpPr txBox="1"/>
          <p:nvPr/>
        </p:nvSpPr>
        <p:spPr>
          <a:xfrm flipH="1">
            <a:off x="5467354" y="2008880"/>
            <a:ext cx="1998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  <a:p>
            <a:pPr algn="ctr"/>
            <a:r>
              <a:rPr lang="en-US" altLang="ko-KR" sz="50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</a:p>
        </p:txBody>
      </p:sp>
      <p:sp>
        <p:nvSpPr>
          <p:cNvPr id="15" name="TextBox 14"/>
          <p:cNvSpPr txBox="1"/>
          <p:nvPr/>
        </p:nvSpPr>
        <p:spPr>
          <a:xfrm flipH="1">
            <a:off x="6002503" y="1690716"/>
            <a:ext cx="2659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  <a:p>
            <a:pPr algn="ctr"/>
            <a:r>
              <a:rPr lang="en-US" altLang="ko-KR" sz="50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</a:p>
          <a:p>
            <a:pPr algn="ctr"/>
            <a:r>
              <a:rPr lang="en-US" altLang="ko-KR" sz="50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</a:p>
          <a:p>
            <a:pPr algn="ctr"/>
            <a:r>
              <a:rPr lang="en-US" altLang="ko-KR" sz="50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255087" y="1064572"/>
            <a:ext cx="3179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af-ZA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2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9158180">
            <a:off x="1519883" y="1416088"/>
            <a:ext cx="576000" cy="215444"/>
          </a:xfrm>
          <a:prstGeom prst="rect">
            <a:avLst/>
          </a:prstGeom>
          <a:noFill/>
          <a:scene3d>
            <a:camera prst="orthographicFront">
              <a:rot lat="0" lon="0" rev="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r>
              <a:rPr lang="en-US" altLang="ko-KR" sz="800">
                <a:latin typeface="Times New Roman" panose="02020603050405020304" pitchFamily="18" charset="0"/>
                <a:cs typeface="Times New Roman" panose="02020603050405020304" pitchFamily="18" charset="0"/>
              </a:rPr>
              <a:t>Normal</a:t>
            </a:r>
            <a:endParaRPr lang="ko-KR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9158180">
            <a:off x="1808571" y="1416088"/>
            <a:ext cx="576000" cy="215444"/>
          </a:xfrm>
          <a:prstGeom prst="rect">
            <a:avLst/>
          </a:prstGeom>
          <a:noFill/>
          <a:scene3d>
            <a:camera prst="orthographicFront">
              <a:rot lat="0" lon="0" rev="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r>
              <a:rPr lang="en-US" altLang="ko-KR" sz="800">
                <a:latin typeface="Times New Roman" panose="02020603050405020304" pitchFamily="18" charset="0"/>
                <a:cs typeface="Times New Roman" panose="02020603050405020304" pitchFamily="18" charset="0"/>
              </a:rPr>
              <a:t>CNV3d</a:t>
            </a:r>
            <a:endParaRPr lang="ko-KR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9158180">
            <a:off x="2053495" y="1416088"/>
            <a:ext cx="576000" cy="215444"/>
          </a:xfrm>
          <a:prstGeom prst="rect">
            <a:avLst/>
          </a:prstGeom>
          <a:noFill/>
          <a:scene3d>
            <a:camera prst="orthographicFront">
              <a:rot lat="0" lon="0" rev="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r>
              <a:rPr lang="en-US" altLang="ko-KR" sz="800">
                <a:latin typeface="Times New Roman" panose="02020603050405020304" pitchFamily="18" charset="0"/>
                <a:cs typeface="Times New Roman" panose="02020603050405020304" pitchFamily="18" charset="0"/>
              </a:rPr>
              <a:t>CNV5d</a:t>
            </a:r>
            <a:endParaRPr lang="ko-KR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9158180">
            <a:off x="2291541" y="1416088"/>
            <a:ext cx="576000" cy="215444"/>
          </a:xfrm>
          <a:prstGeom prst="rect">
            <a:avLst/>
          </a:prstGeom>
          <a:noFill/>
          <a:scene3d>
            <a:camera prst="orthographicFront">
              <a:rot lat="0" lon="0" rev="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r>
              <a:rPr lang="en-US" altLang="ko-KR" sz="800">
                <a:latin typeface="Times New Roman" panose="02020603050405020304" pitchFamily="18" charset="0"/>
                <a:cs typeface="Times New Roman" panose="02020603050405020304" pitchFamily="18" charset="0"/>
              </a:rPr>
              <a:t>CNV7d</a:t>
            </a:r>
            <a:endParaRPr lang="ko-KR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9158180">
            <a:off x="2528651" y="1416092"/>
            <a:ext cx="576000" cy="215444"/>
          </a:xfrm>
          <a:prstGeom prst="rect">
            <a:avLst/>
          </a:prstGeom>
          <a:noFill/>
          <a:scene3d>
            <a:camera prst="orthographicFront">
              <a:rot lat="0" lon="0" rev="0"/>
            </a:camera>
            <a:lightRig rig="threePt" dir="t"/>
          </a:scene3d>
        </p:spPr>
        <p:txBody>
          <a:bodyPr wrap="square" rtlCol="0">
            <a:spAutoFit/>
          </a:bodyPr>
          <a:lstStyle/>
          <a:p>
            <a:r>
              <a:rPr lang="en-US" altLang="ko-KR" sz="800">
                <a:latin typeface="Times New Roman" panose="02020603050405020304" pitchFamily="18" charset="0"/>
                <a:cs typeface="Times New Roman" panose="02020603050405020304" pitchFamily="18" charset="0"/>
              </a:rPr>
              <a:t>CNV12d</a:t>
            </a:r>
            <a:endParaRPr lang="ko-KR" altLang="en-US" sz="8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Picture 4"/>
          <p:cNvPicPr preferRelativeResize="0">
            <a:picLocks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083" t="74986" r="21774" b="19194"/>
          <a:stretch/>
        </p:blipFill>
        <p:spPr bwMode="auto">
          <a:xfrm>
            <a:off x="1511469" y="1722375"/>
            <a:ext cx="1296000" cy="190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3" name="차트 22"/>
          <p:cNvGraphicFramePr>
            <a:graphicFrameLocks/>
          </p:cNvGraphicFramePr>
          <p:nvPr>
            <p:extLst/>
          </p:nvPr>
        </p:nvGraphicFramePr>
        <p:xfrm>
          <a:off x="3236643" y="1127827"/>
          <a:ext cx="3326400" cy="192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4" name="Rectangle 24"/>
          <p:cNvSpPr/>
          <p:nvPr/>
        </p:nvSpPr>
        <p:spPr>
          <a:xfrm>
            <a:off x="3224881" y="488506"/>
            <a:ext cx="3429000" cy="246221"/>
          </a:xfrm>
          <a:prstGeom prst="rect">
            <a:avLst/>
          </a:prstGeom>
        </p:spPr>
        <p:txBody>
          <a:bodyPr>
            <a:spAutoFit/>
          </a:bodyPr>
          <a:lstStyle/>
          <a:p>
            <a:pPr algn="r">
              <a:tabLst>
                <a:tab pos="2971486" algn="ctr"/>
                <a:tab pos="5942970" algn="r"/>
              </a:tabLst>
            </a:pPr>
            <a:r>
              <a:rPr lang="en-US" sz="1000">
                <a:latin typeface="Times New Roman" panose="0202060305040502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mTORC1 and mTORC2 differentially contribute to CNV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724761" y="1701882"/>
            <a:ext cx="5171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ko-KR" altLang="en-US" sz="5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← </a:t>
            </a:r>
            <a:r>
              <a:rPr lang="en-US" altLang="ko-KR" sz="5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4kDa</a:t>
            </a:r>
          </a:p>
          <a:p>
            <a:r>
              <a:rPr lang="en-US" altLang="ko-KR" sz="5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← 42kDa</a:t>
            </a:r>
            <a:endParaRPr lang="ko-KR" altLang="en-US" sz="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724761" y="2031725"/>
            <a:ext cx="51719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ko-KR" altLang="en-US" sz="5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← </a:t>
            </a:r>
            <a:r>
              <a:rPr lang="en-US" altLang="ko-KR" sz="5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4kDa</a:t>
            </a:r>
          </a:p>
          <a:p>
            <a:r>
              <a:rPr lang="en-US" altLang="ko-KR" sz="5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← 42kDa</a:t>
            </a:r>
            <a:endParaRPr lang="ko-KR" altLang="en-US" sz="5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724761" y="2402523"/>
            <a:ext cx="51719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ko-KR" altLang="en-US" sz="5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← </a:t>
            </a:r>
            <a:r>
              <a:rPr lang="en-US" altLang="ko-KR" sz="5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3kDa</a:t>
            </a:r>
          </a:p>
        </p:txBody>
      </p:sp>
    </p:spTree>
    <p:extLst>
      <p:ext uri="{BB962C8B-B14F-4D97-AF65-F5344CB8AC3E}">
        <p14:creationId xmlns:p14="http://schemas.microsoft.com/office/powerpoint/2010/main" val="587274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95</Words>
  <Application>Microsoft Office PowerPoint</Application>
  <PresentationFormat>A4 Paper (210x297 mm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roswellgirl111@gmail.com</dc:creator>
  <cp:lastModifiedBy>Tose, Junalyn</cp:lastModifiedBy>
  <cp:revision>2</cp:revision>
  <dcterms:created xsi:type="dcterms:W3CDTF">2019-03-30T09:35:56Z</dcterms:created>
  <dcterms:modified xsi:type="dcterms:W3CDTF">2019-06-13T03:13:27Z</dcterms:modified>
</cp:coreProperties>
</file>